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83" d="100"/>
          <a:sy n="83" d="100"/>
        </p:scale>
        <p:origin x="65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B2DC-E07F-41C8-BCA4-70FED93C24ED}" type="datetimeFigureOut">
              <a:rPr lang="zh-CN" altLang="en-US" smtClean="0"/>
              <a:t>2020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8324C-F414-4484-A175-AF93A68F1C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73543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B2DC-E07F-41C8-BCA4-70FED93C24ED}" type="datetimeFigureOut">
              <a:rPr lang="zh-CN" altLang="en-US" smtClean="0"/>
              <a:t>2020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8324C-F414-4484-A175-AF93A68F1C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6196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B2DC-E07F-41C8-BCA4-70FED93C24ED}" type="datetimeFigureOut">
              <a:rPr lang="zh-CN" altLang="en-US" smtClean="0"/>
              <a:t>2020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8324C-F414-4484-A175-AF93A68F1C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90056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B2DC-E07F-41C8-BCA4-70FED93C24ED}" type="datetimeFigureOut">
              <a:rPr lang="zh-CN" altLang="en-US" smtClean="0"/>
              <a:t>2020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8324C-F414-4484-A175-AF93A68F1C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3142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B2DC-E07F-41C8-BCA4-70FED93C24ED}" type="datetimeFigureOut">
              <a:rPr lang="zh-CN" altLang="en-US" smtClean="0"/>
              <a:t>2020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8324C-F414-4484-A175-AF93A68F1C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9180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B2DC-E07F-41C8-BCA4-70FED93C24ED}" type="datetimeFigureOut">
              <a:rPr lang="zh-CN" altLang="en-US" smtClean="0"/>
              <a:t>2020/5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8324C-F414-4484-A175-AF93A68F1C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0061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B2DC-E07F-41C8-BCA4-70FED93C24ED}" type="datetimeFigureOut">
              <a:rPr lang="zh-CN" altLang="en-US" smtClean="0"/>
              <a:t>2020/5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8324C-F414-4484-A175-AF93A68F1C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70848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B2DC-E07F-41C8-BCA4-70FED93C24ED}" type="datetimeFigureOut">
              <a:rPr lang="zh-CN" altLang="en-US" smtClean="0"/>
              <a:t>2020/5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8324C-F414-4484-A175-AF93A68F1C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6723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B2DC-E07F-41C8-BCA4-70FED93C24ED}" type="datetimeFigureOut">
              <a:rPr lang="zh-CN" altLang="en-US" smtClean="0"/>
              <a:t>2020/5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8324C-F414-4484-A175-AF93A68F1C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852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B2DC-E07F-41C8-BCA4-70FED93C24ED}" type="datetimeFigureOut">
              <a:rPr lang="zh-CN" altLang="en-US" smtClean="0"/>
              <a:t>2020/5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8324C-F414-4484-A175-AF93A68F1C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9197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8B2DC-E07F-41C8-BCA4-70FED93C24ED}" type="datetimeFigureOut">
              <a:rPr lang="zh-CN" altLang="en-US" smtClean="0"/>
              <a:t>2020/5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8324C-F414-4484-A175-AF93A68F1C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7525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58B2DC-E07F-41C8-BCA4-70FED93C24ED}" type="datetimeFigureOut">
              <a:rPr lang="zh-CN" altLang="en-US" smtClean="0"/>
              <a:t>2020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8324C-F414-4484-A175-AF93A68F1C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79136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2801815" y="2420035"/>
            <a:ext cx="8047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kern="0" dirty="0">
                <a:latin typeface="Arial" panose="020B0604020202020204" pitchFamily="34" charset="0"/>
              </a:rPr>
              <a:t>A novel gene </a:t>
            </a:r>
            <a:r>
              <a:rPr lang="en-US" altLang="zh-CN" i="1" kern="0" dirty="0">
                <a:latin typeface="Arial" panose="020B0604020202020204" pitchFamily="34" charset="0"/>
              </a:rPr>
              <a:t>OsTBP2.2</a:t>
            </a:r>
            <a:r>
              <a:rPr lang="en-US" altLang="zh-CN" kern="0" dirty="0">
                <a:latin typeface="Arial" panose="020B0604020202020204" pitchFamily="34" charset="0"/>
              </a:rPr>
              <a:t> for resistance to drought stress in ric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174236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4048075"/>
              </p:ext>
            </p:extLst>
          </p:nvPr>
        </p:nvGraphicFramePr>
        <p:xfrm>
          <a:off x="1780310" y="1613694"/>
          <a:ext cx="7874000" cy="2971800"/>
        </p:xfrm>
        <a:graphic>
          <a:graphicData uri="http://schemas.openxmlformats.org/drawingml/2006/table">
            <a:tbl>
              <a:tblPr/>
              <a:tblGrid>
                <a:gridCol w="1778000">
                  <a:extLst>
                    <a:ext uri="{9D8B030D-6E8A-4147-A177-3AD203B41FA5}">
                      <a16:colId xmlns:a16="http://schemas.microsoft.com/office/drawing/2014/main" val="4162798920"/>
                    </a:ext>
                  </a:extLst>
                </a:gridCol>
                <a:gridCol w="3136900">
                  <a:extLst>
                    <a:ext uri="{9D8B030D-6E8A-4147-A177-3AD203B41FA5}">
                      <a16:colId xmlns:a16="http://schemas.microsoft.com/office/drawing/2014/main" val="1337213027"/>
                    </a:ext>
                  </a:extLst>
                </a:gridCol>
                <a:gridCol w="2959100">
                  <a:extLst>
                    <a:ext uri="{9D8B030D-6E8A-4147-A177-3AD203B41FA5}">
                      <a16:colId xmlns:a16="http://schemas.microsoft.com/office/drawing/2014/main" val="2564915611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dentification primer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orward primer (5'to3'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verse primer (5'to3'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38670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A-0700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TTCCCAGCAAAGTTCA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ACAATGCATGTCACACAG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530311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A-1156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GCCTTCTTATGCTGTGC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TTATACGGAGGAGGGGG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202864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al-time PCR primer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5324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qOsPAO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AAATCCTAGCCAAGAAGTGTT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GCAGGAATCCCAGCAG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682455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qOsRCCR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GATCGACGATTGATTTCAT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CGCTGTTTGTCCACCTGAG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638949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qOsPiz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ATGCTGATACTTGGGGCATTG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AGCCCAGCCACTTTACTTCC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649083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qGHR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GCCATCTCCCTCGTTCA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ACCCAATCAGTCAGGTC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858006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qOsPIP2;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GCCAGGTGCATGATTTG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CGAAGCAGTTTGTATCT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315121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qOsRLCK13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TGTTTCTGTGCCGTAGCT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GGTCCTCCTTCCATTTGC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921692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qOsZFP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CCTCCTGATGAGAAAACG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GAGCCTCCGCCATAGT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628389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q</a:t>
                      </a:r>
                      <a:r>
                        <a:rPr lang="en-US" sz="14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sDREB2a</a:t>
                      </a:r>
                      <a:endParaRPr lang="en-US" sz="14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CTGAGATCCGTGAACCA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ACCATACATTGCCCTTG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165174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qOsTBP2.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TGGCTTCCCAGCAAAG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CACAATCTTTGGCTGC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0200991"/>
                  </a:ext>
                </a:extLst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1256145" y="683491"/>
            <a:ext cx="29648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Table S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15370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62</Words>
  <Application>Microsoft Office PowerPoint</Application>
  <PresentationFormat>宽屏</PresentationFormat>
  <Paragraphs>39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ng yong</dc:creator>
  <cp:lastModifiedBy>zhang yong</cp:lastModifiedBy>
  <cp:revision>3</cp:revision>
  <dcterms:created xsi:type="dcterms:W3CDTF">2020-05-11T01:35:33Z</dcterms:created>
  <dcterms:modified xsi:type="dcterms:W3CDTF">2020-05-11T07:16:25Z</dcterms:modified>
</cp:coreProperties>
</file>